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570" y="-3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95758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27124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30455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650723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813905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5543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9425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200404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71354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1229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929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E7BE88-F3DE-458C-ACB2-297FE59D82BB}" type="datetimeFigureOut">
              <a:rPr lang="en-NZ" smtClean="0"/>
              <a:t>22/12/2014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AC2A17-74F5-4EEC-9238-80BB8EEABF6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45451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3" name="Group 262"/>
          <p:cNvGrpSpPr/>
          <p:nvPr/>
        </p:nvGrpSpPr>
        <p:grpSpPr>
          <a:xfrm>
            <a:off x="1083753" y="1573882"/>
            <a:ext cx="4505487" cy="5194362"/>
            <a:chOff x="404664" y="1079612"/>
            <a:chExt cx="4505487" cy="5194362"/>
          </a:xfrm>
        </p:grpSpPr>
        <p:pic>
          <p:nvPicPr>
            <p:cNvPr id="264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664" y="1187624"/>
              <a:ext cx="2381251" cy="2571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5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664" y="3702224"/>
              <a:ext cx="2381251" cy="2571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66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28900" y="1187624"/>
              <a:ext cx="2381251" cy="2571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67" name="TextBox 266"/>
            <p:cNvSpPr txBox="1"/>
            <p:nvPr/>
          </p:nvSpPr>
          <p:spPr>
            <a:xfrm>
              <a:off x="3337850" y="3399567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7AAD </a:t>
              </a:r>
              <a:endParaRPr lang="en-US" sz="1200" dirty="0"/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1166666" y="5904642"/>
              <a:ext cx="5725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7AAD </a:t>
              </a:r>
              <a:endParaRPr lang="en-US" sz="1200" dirty="0"/>
            </a:p>
          </p:txBody>
        </p:sp>
        <p:cxnSp>
          <p:nvCxnSpPr>
            <p:cNvPr id="269" name="Straight Connector 268"/>
            <p:cNvCxnSpPr/>
            <p:nvPr/>
          </p:nvCxnSpPr>
          <p:spPr>
            <a:xfrm>
              <a:off x="1014264" y="2635424"/>
              <a:ext cx="762000" cy="175260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 flipV="1">
              <a:off x="1700064" y="2411760"/>
              <a:ext cx="1116868" cy="2961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Box 270"/>
            <p:cNvSpPr txBox="1"/>
            <p:nvPr/>
          </p:nvSpPr>
          <p:spPr>
            <a:xfrm>
              <a:off x="2636912" y="3995936"/>
              <a:ext cx="975075" cy="64633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Auto 0-0-0-0</a:t>
              </a:r>
            </a:p>
            <a:p>
              <a:r>
                <a:rPr lang="en-US" sz="1200" dirty="0" smtClean="0">
                  <a:solidFill>
                    <a:srgbClr val="0000FF"/>
                  </a:solidFill>
                </a:rPr>
                <a:t>Basal 7AAD</a:t>
              </a:r>
            </a:p>
            <a:p>
              <a:r>
                <a:rPr lang="en-US" sz="1200" dirty="0" smtClean="0">
                  <a:solidFill>
                    <a:srgbClr val="FF0000"/>
                  </a:solidFill>
                </a:rPr>
                <a:t>IL-1 7AAD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692696" y="3599892"/>
              <a:ext cx="99302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P2 dead gate</a:t>
              </a:r>
              <a:endParaRPr lang="en-US" sz="1200" dirty="0"/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2846040" y="1079612"/>
              <a:ext cx="126014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1 live gate</a:t>
              </a:r>
              <a:endParaRPr lang="en-US" sz="1200" dirty="0"/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728700" y="1079612"/>
              <a:ext cx="126014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Gating strategy</a:t>
              </a:r>
              <a:endParaRPr lang="en-US" sz="1200" dirty="0"/>
            </a:p>
          </p:txBody>
        </p:sp>
      </p:grpSp>
      <p:sp>
        <p:nvSpPr>
          <p:cNvPr id="275" name="TextBox 274"/>
          <p:cNvSpPr txBox="1"/>
          <p:nvPr/>
        </p:nvSpPr>
        <p:spPr>
          <a:xfrm>
            <a:off x="402779" y="509935"/>
            <a:ext cx="60486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al Figure 3. Gating strategy for the determination of live (P1) and dead gates (P2) for the cell surface analysis of endothelial adhesion molecules. </a:t>
            </a:r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1040870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6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8</cp:revision>
  <dcterms:created xsi:type="dcterms:W3CDTF">2014-12-21T23:06:00Z</dcterms:created>
  <dcterms:modified xsi:type="dcterms:W3CDTF">2014-12-21T23:11:19Z</dcterms:modified>
</cp:coreProperties>
</file>